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1C04A-8EFB-45AF-8585-93079138C7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D5FA3-088C-4ED8-9600-BD570655BF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A6647B-078E-43B4-8077-0D7F85C7D3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FE535-A343-4EAB-88B2-84DD239925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1751F-BDB9-411F-819D-7E7710E3E0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8A6597-2BBA-4144-9FB4-5C5E01AB16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2D9BE-5ECF-44FA-B8DE-D67D59CC37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59454-40D9-4F49-B76B-E0D755AD0C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FFDF79-A22E-483F-AA6D-1941D4A90B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2495C-A15C-41A6-9833-39C3DD109F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F32B6C-8ADC-4D21-B9B3-CCABE73AE0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D889E6-DCE4-4BA3-8DDF-D1ECACD6F0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EBCB41-1EE7-4414-9A2D-457C229BD4BC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8.jpe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86"/>
          <p:cNvGrpSpPr/>
          <p:nvPr/>
        </p:nvGrpSpPr>
        <p:grpSpPr>
          <a:xfrm>
            <a:off x="320760" y="755640"/>
            <a:ext cx="7491240" cy="3813120"/>
            <a:chOff x="320760" y="755640"/>
            <a:chExt cx="7491240" cy="3813120"/>
          </a:xfrm>
        </p:grpSpPr>
        <p:sp>
          <p:nvSpPr>
            <p:cNvPr id="42" name="Rectangle 33"/>
            <p:cNvSpPr/>
            <p:nvPr/>
          </p:nvSpPr>
          <p:spPr>
            <a:xfrm flipV="1" rot="10800000">
              <a:off x="981000" y="2130480"/>
              <a:ext cx="2705040" cy="150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Box 34"/>
            <p:cNvSpPr/>
            <p:nvPr/>
          </p:nvSpPr>
          <p:spPr>
            <a:xfrm>
              <a:off x="3002040" y="1138680"/>
              <a:ext cx="1785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RP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Box 35"/>
            <p:cNvSpPr/>
            <p:nvPr/>
          </p:nvSpPr>
          <p:spPr>
            <a:xfrm>
              <a:off x="2760480" y="1712880"/>
              <a:ext cx="1785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← </a:t>
              </a:r>
              <a:r>
                <a:rPr b="0" lang="el-GR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α</a:t>
              </a: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tubulin, 55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54"/>
            <p:cNvSpPr/>
            <p:nvPr/>
          </p:nvSpPr>
          <p:spPr>
            <a:xfrm>
              <a:off x="320760" y="99540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55"/>
            <p:cNvSpPr/>
            <p:nvPr/>
          </p:nvSpPr>
          <p:spPr>
            <a:xfrm>
              <a:off x="322200" y="128268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56"/>
            <p:cNvSpPr/>
            <p:nvPr/>
          </p:nvSpPr>
          <p:spPr>
            <a:xfrm>
              <a:off x="435240" y="185868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20" descr="F:\061109 total etop tubulin tc32.jpg"/>
            <p:cNvPicPr/>
            <p:nvPr/>
          </p:nvPicPr>
          <p:blipFill>
            <a:blip r:embed="rId1"/>
            <a:srcRect l="4765" t="54759" r="55093" b="23366"/>
            <a:stretch/>
          </p:blipFill>
          <p:spPr>
            <a:xfrm>
              <a:off x="982800" y="1668600"/>
              <a:ext cx="1804320" cy="49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17" descr="F:\061109 total mrp1 etop tc32.jpg"/>
            <p:cNvPicPr/>
            <p:nvPr/>
          </p:nvPicPr>
          <p:blipFill>
            <a:blip r:embed="rId2"/>
            <a:srcRect l="3916" t="5086" r="55669" b="72044"/>
            <a:stretch/>
          </p:blipFill>
          <p:spPr>
            <a:xfrm>
              <a:off x="946080" y="1073160"/>
              <a:ext cx="1841040" cy="642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Right Brace 51"/>
            <p:cNvSpPr/>
            <p:nvPr/>
          </p:nvSpPr>
          <p:spPr>
            <a:xfrm>
              <a:off x="2859120" y="1041120"/>
              <a:ext cx="71280" cy="428400"/>
            </a:xfrm>
            <a:custGeom>
              <a:avLst/>
              <a:gdLst>
                <a:gd name="textAreaLeft" fmla="*/ 0 w 71280"/>
                <a:gd name="textAreaRight" fmla="*/ 25560 w 71280"/>
                <a:gd name="textAreaTop" fmla="*/ 1800 h 428400"/>
                <a:gd name="textAreaBottom" fmla="*/ 426600 h 428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50"/>
                    <a:pt x="10800" y="300"/>
                  </a:cubicBezTo>
                  <a:lnTo>
                    <a:pt x="10800" y="10500"/>
                  </a:lnTo>
                  <a:cubicBezTo>
                    <a:pt x="10800" y="10650"/>
                    <a:pt x="16200" y="10800"/>
                    <a:pt x="21600" y="10800"/>
                  </a:cubicBezTo>
                  <a:cubicBezTo>
                    <a:pt x="16200" y="10800"/>
                    <a:pt x="10800" y="10950"/>
                    <a:pt x="10800" y="11100"/>
                  </a:cubicBezTo>
                  <a:lnTo>
                    <a:pt x="10800" y="21300"/>
                  </a:lnTo>
                  <a:cubicBezTo>
                    <a:pt x="10800" y="21450"/>
                    <a:pt x="5400" y="21600"/>
                    <a:pt x="0" y="21600"/>
                  </a:cubicBezTo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22"/>
            <p:cNvSpPr/>
            <p:nvPr/>
          </p:nvSpPr>
          <p:spPr>
            <a:xfrm>
              <a:off x="3006720" y="3076200"/>
              <a:ext cx="1785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RP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23"/>
            <p:cNvSpPr/>
            <p:nvPr/>
          </p:nvSpPr>
          <p:spPr>
            <a:xfrm>
              <a:off x="2796840" y="3842640"/>
              <a:ext cx="1785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← </a:t>
              </a: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aKATPase, ~110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48"/>
            <p:cNvSpPr/>
            <p:nvPr/>
          </p:nvSpPr>
          <p:spPr>
            <a:xfrm>
              <a:off x="385920" y="294768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49"/>
            <p:cNvSpPr/>
            <p:nvPr/>
          </p:nvSpPr>
          <p:spPr>
            <a:xfrm>
              <a:off x="387360" y="323496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50"/>
            <p:cNvSpPr/>
            <p:nvPr/>
          </p:nvSpPr>
          <p:spPr>
            <a:xfrm>
              <a:off x="397080" y="369216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51"/>
            <p:cNvSpPr/>
            <p:nvPr/>
          </p:nvSpPr>
          <p:spPr>
            <a:xfrm>
              <a:off x="476280" y="398088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5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7" name="Picture 11" descr="F:\061109 membrane mrp1 etop tc32.jpg"/>
            <p:cNvPicPr/>
            <p:nvPr/>
          </p:nvPicPr>
          <p:blipFill>
            <a:blip r:embed="rId3">
              <a:lum bright="10000"/>
            </a:blip>
            <a:srcRect l="11083" t="3872" r="50424" b="68575"/>
            <a:stretch/>
          </p:blipFill>
          <p:spPr>
            <a:xfrm>
              <a:off x="1038240" y="2949120"/>
              <a:ext cx="1775520" cy="642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14" descr="F:\061109 membrane mrp1 etop nakatpase.jpg"/>
            <p:cNvPicPr/>
            <p:nvPr/>
          </p:nvPicPr>
          <p:blipFill>
            <a:blip r:embed="rId4"/>
            <a:srcRect l="9537" t="33678" r="51930" b="41839"/>
            <a:stretch/>
          </p:blipFill>
          <p:spPr>
            <a:xfrm>
              <a:off x="1028520" y="3742920"/>
              <a:ext cx="1785240" cy="570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Right Brace 53"/>
            <p:cNvSpPr/>
            <p:nvPr/>
          </p:nvSpPr>
          <p:spPr>
            <a:xfrm>
              <a:off x="2886120" y="3005280"/>
              <a:ext cx="71280" cy="428400"/>
            </a:xfrm>
            <a:custGeom>
              <a:avLst/>
              <a:gdLst>
                <a:gd name="textAreaLeft" fmla="*/ 0 w 71280"/>
                <a:gd name="textAreaRight" fmla="*/ 25560 w 71280"/>
                <a:gd name="textAreaTop" fmla="*/ 1800 h 428400"/>
                <a:gd name="textAreaBottom" fmla="*/ 426600 h 428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50"/>
                    <a:pt x="10800" y="300"/>
                  </a:cubicBezTo>
                  <a:lnTo>
                    <a:pt x="10800" y="10500"/>
                  </a:lnTo>
                  <a:cubicBezTo>
                    <a:pt x="10800" y="10650"/>
                    <a:pt x="16200" y="10800"/>
                    <a:pt x="21600" y="10800"/>
                  </a:cubicBezTo>
                  <a:cubicBezTo>
                    <a:pt x="16200" y="10800"/>
                    <a:pt x="10800" y="10950"/>
                    <a:pt x="10800" y="11100"/>
                  </a:cubicBezTo>
                  <a:lnTo>
                    <a:pt x="10800" y="21300"/>
                  </a:lnTo>
                  <a:cubicBezTo>
                    <a:pt x="10800" y="21450"/>
                    <a:pt x="5400" y="21600"/>
                    <a:pt x="0" y="21600"/>
                  </a:cubicBezTo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35"/>
            <p:cNvSpPr/>
            <p:nvPr/>
          </p:nvSpPr>
          <p:spPr>
            <a:xfrm>
              <a:off x="6703920" y="3698280"/>
              <a:ext cx="1108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← </a:t>
              </a: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ATA, 38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5"/>
            <p:cNvSpPr/>
            <p:nvPr/>
          </p:nvSpPr>
          <p:spPr>
            <a:xfrm>
              <a:off x="4272120" y="373860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7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26"/>
            <p:cNvSpPr/>
            <p:nvPr/>
          </p:nvSpPr>
          <p:spPr>
            <a:xfrm>
              <a:off x="6862680" y="3162240"/>
              <a:ext cx="66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RP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52"/>
            <p:cNvSpPr/>
            <p:nvPr/>
          </p:nvSpPr>
          <p:spPr>
            <a:xfrm>
              <a:off x="4214880" y="299628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53"/>
            <p:cNvSpPr/>
            <p:nvPr/>
          </p:nvSpPr>
          <p:spPr>
            <a:xfrm>
              <a:off x="4216680" y="328320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5" name="Picture 4" descr="E:\261109 nuc tc32 etop tata tbp.jpg"/>
            <p:cNvPicPr/>
            <p:nvPr/>
          </p:nvPicPr>
          <p:blipFill>
            <a:blip r:embed="rId5"/>
            <a:srcRect l="1812" t="58131" r="53473" b="16974"/>
            <a:stretch/>
          </p:blipFill>
          <p:spPr>
            <a:xfrm>
              <a:off x="4802400" y="3495960"/>
              <a:ext cx="1841400" cy="64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7" descr="E:\120110 tc32 nuc etop mrp1 rep 2.jpg"/>
            <p:cNvPicPr/>
            <p:nvPr/>
          </p:nvPicPr>
          <p:blipFill>
            <a:blip r:embed="rId6"/>
            <a:srcRect l="6845" t="12416" r="47735" b="62753"/>
            <a:stretch/>
          </p:blipFill>
          <p:spPr>
            <a:xfrm>
              <a:off x="4813200" y="3016800"/>
              <a:ext cx="1901520" cy="642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Right Brace 66"/>
            <p:cNvSpPr/>
            <p:nvPr/>
          </p:nvSpPr>
          <p:spPr>
            <a:xfrm>
              <a:off x="6786720" y="3065400"/>
              <a:ext cx="71280" cy="428400"/>
            </a:xfrm>
            <a:custGeom>
              <a:avLst/>
              <a:gdLst>
                <a:gd name="textAreaLeft" fmla="*/ 0 w 71280"/>
                <a:gd name="textAreaRight" fmla="*/ 25560 w 71280"/>
                <a:gd name="textAreaTop" fmla="*/ 1800 h 428400"/>
                <a:gd name="textAreaBottom" fmla="*/ 426600 h 428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50"/>
                    <a:pt x="10800" y="300"/>
                  </a:cubicBezTo>
                  <a:lnTo>
                    <a:pt x="10800" y="10500"/>
                  </a:lnTo>
                  <a:cubicBezTo>
                    <a:pt x="10800" y="10650"/>
                    <a:pt x="16200" y="10800"/>
                    <a:pt x="21600" y="10800"/>
                  </a:cubicBezTo>
                  <a:cubicBezTo>
                    <a:pt x="16200" y="10800"/>
                    <a:pt x="10800" y="10950"/>
                    <a:pt x="10800" y="11100"/>
                  </a:cubicBezTo>
                  <a:lnTo>
                    <a:pt x="10800" y="21300"/>
                  </a:lnTo>
                  <a:cubicBezTo>
                    <a:pt x="10800" y="21450"/>
                    <a:pt x="5400" y="21600"/>
                    <a:pt x="0" y="21600"/>
                  </a:cubicBezTo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26"/>
            <p:cNvSpPr/>
            <p:nvPr/>
          </p:nvSpPr>
          <p:spPr>
            <a:xfrm>
              <a:off x="6771600" y="1156320"/>
              <a:ext cx="608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RP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27"/>
            <p:cNvSpPr/>
            <p:nvPr/>
          </p:nvSpPr>
          <p:spPr>
            <a:xfrm>
              <a:off x="6527160" y="1748880"/>
              <a:ext cx="114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← </a:t>
              </a: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p75, 74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52"/>
            <p:cNvSpPr/>
            <p:nvPr/>
          </p:nvSpPr>
          <p:spPr>
            <a:xfrm>
              <a:off x="4139640" y="87336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53"/>
            <p:cNvSpPr/>
            <p:nvPr/>
          </p:nvSpPr>
          <p:spPr>
            <a:xfrm>
              <a:off x="4141440" y="116064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57"/>
            <p:cNvSpPr/>
            <p:nvPr/>
          </p:nvSpPr>
          <p:spPr>
            <a:xfrm>
              <a:off x="4222440" y="172224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5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3" name="Picture 17" descr="E:\150110 tc32 mito etop mrp1 rep 2.jpg"/>
            <p:cNvPicPr/>
            <p:nvPr/>
          </p:nvPicPr>
          <p:blipFill>
            <a:blip r:embed="rId7"/>
            <a:srcRect l="10900" t="0" r="44907" b="65922"/>
            <a:stretch/>
          </p:blipFill>
          <p:spPr>
            <a:xfrm>
              <a:off x="4777920" y="851040"/>
              <a:ext cx="1785240" cy="785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Right Brace 52"/>
            <p:cNvSpPr/>
            <p:nvPr/>
          </p:nvSpPr>
          <p:spPr>
            <a:xfrm>
              <a:off x="6635880" y="1052280"/>
              <a:ext cx="71280" cy="428400"/>
            </a:xfrm>
            <a:custGeom>
              <a:avLst/>
              <a:gdLst>
                <a:gd name="textAreaLeft" fmla="*/ 0 w 71280"/>
                <a:gd name="textAreaRight" fmla="*/ 25560 w 71280"/>
                <a:gd name="textAreaTop" fmla="*/ 1800 h 428400"/>
                <a:gd name="textAreaBottom" fmla="*/ 426600 h 428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50"/>
                    <a:pt x="10800" y="300"/>
                  </a:cubicBezTo>
                  <a:lnTo>
                    <a:pt x="10800" y="10500"/>
                  </a:lnTo>
                  <a:cubicBezTo>
                    <a:pt x="10800" y="10650"/>
                    <a:pt x="16200" y="10800"/>
                    <a:pt x="21600" y="10800"/>
                  </a:cubicBezTo>
                  <a:cubicBezTo>
                    <a:pt x="16200" y="10800"/>
                    <a:pt x="10800" y="10950"/>
                    <a:pt x="10800" y="11100"/>
                  </a:cubicBezTo>
                  <a:lnTo>
                    <a:pt x="10800" y="21300"/>
                  </a:lnTo>
                  <a:cubicBezTo>
                    <a:pt x="10800" y="21450"/>
                    <a:pt x="5400" y="21600"/>
                    <a:pt x="0" y="21600"/>
                  </a:cubicBezTo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5" name="Picture 10" descr="P:\Lab4\Liz R\papers\mitochondrial MRP-1\GRP75 re probed blots\160211 grp75 re probe mito etop inc dose paper.jpg"/>
            <p:cNvPicPr/>
            <p:nvPr/>
          </p:nvPicPr>
          <p:blipFill>
            <a:blip r:embed="rId8"/>
            <a:srcRect l="23903" t="13724" r="43089" b="78441"/>
            <a:stretch/>
          </p:blipFill>
          <p:spPr>
            <a:xfrm>
              <a:off x="5031360" y="1792440"/>
              <a:ext cx="153540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10" descr="P:\Lab4\Liz R\papers\mitochondrial MRP-1\GRP75 re probed blots\160211 grp75 re probe mito etop inc dose paper.jpg"/>
            <p:cNvPicPr/>
            <p:nvPr/>
          </p:nvPicPr>
          <p:blipFill>
            <a:blip r:embed="rId9"/>
            <a:srcRect l="5557" t="15683" r="88757" b="76483"/>
            <a:stretch/>
          </p:blipFill>
          <p:spPr>
            <a:xfrm>
              <a:off x="4766400" y="1792440"/>
              <a:ext cx="264600" cy="21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Text Box 59"/>
            <p:cNvSpPr/>
            <p:nvPr/>
          </p:nvSpPr>
          <p:spPr>
            <a:xfrm>
              <a:off x="2359440" y="84816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Tot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59"/>
            <p:cNvSpPr/>
            <p:nvPr/>
          </p:nvSpPr>
          <p:spPr>
            <a:xfrm>
              <a:off x="1663920" y="2767320"/>
              <a:ext cx="134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Plasma membran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59"/>
            <p:cNvSpPr/>
            <p:nvPr/>
          </p:nvSpPr>
          <p:spPr>
            <a:xfrm>
              <a:off x="5731560" y="755640"/>
              <a:ext cx="134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Mitochondri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59"/>
            <p:cNvSpPr/>
            <p:nvPr/>
          </p:nvSpPr>
          <p:spPr>
            <a:xfrm>
              <a:off x="6175080" y="278964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Nuclea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38"/>
            <p:cNvSpPr/>
            <p:nvPr/>
          </p:nvSpPr>
          <p:spPr>
            <a:xfrm>
              <a:off x="910800" y="2124000"/>
              <a:ext cx="57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39"/>
            <p:cNvSpPr/>
            <p:nvPr/>
          </p:nvSpPr>
          <p:spPr>
            <a:xfrm>
              <a:off x="1318680" y="2124000"/>
              <a:ext cx="57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40"/>
            <p:cNvSpPr/>
            <p:nvPr/>
          </p:nvSpPr>
          <p:spPr>
            <a:xfrm>
              <a:off x="1652040" y="212400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41"/>
            <p:cNvSpPr/>
            <p:nvPr/>
          </p:nvSpPr>
          <p:spPr>
            <a:xfrm>
              <a:off x="1955880" y="212400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42"/>
            <p:cNvSpPr/>
            <p:nvPr/>
          </p:nvSpPr>
          <p:spPr>
            <a:xfrm>
              <a:off x="2251080" y="212400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43"/>
            <p:cNvSpPr/>
            <p:nvPr/>
          </p:nvSpPr>
          <p:spPr>
            <a:xfrm>
              <a:off x="2538360" y="212400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65"/>
            <p:cNvSpPr/>
            <p:nvPr/>
          </p:nvSpPr>
          <p:spPr>
            <a:xfrm>
              <a:off x="2863080" y="2124000"/>
              <a:ext cx="431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38"/>
            <p:cNvSpPr/>
            <p:nvPr/>
          </p:nvSpPr>
          <p:spPr>
            <a:xfrm>
              <a:off x="4655160" y="2018160"/>
              <a:ext cx="57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39"/>
            <p:cNvSpPr/>
            <p:nvPr/>
          </p:nvSpPr>
          <p:spPr>
            <a:xfrm>
              <a:off x="5063040" y="2018160"/>
              <a:ext cx="57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40"/>
            <p:cNvSpPr/>
            <p:nvPr/>
          </p:nvSpPr>
          <p:spPr>
            <a:xfrm>
              <a:off x="5396400" y="201816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Box 41"/>
            <p:cNvSpPr/>
            <p:nvPr/>
          </p:nvSpPr>
          <p:spPr>
            <a:xfrm>
              <a:off x="5700240" y="201816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42"/>
            <p:cNvSpPr/>
            <p:nvPr/>
          </p:nvSpPr>
          <p:spPr>
            <a:xfrm>
              <a:off x="5995440" y="201816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43"/>
            <p:cNvSpPr/>
            <p:nvPr/>
          </p:nvSpPr>
          <p:spPr>
            <a:xfrm>
              <a:off x="6282720" y="201816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65"/>
            <p:cNvSpPr/>
            <p:nvPr/>
          </p:nvSpPr>
          <p:spPr>
            <a:xfrm>
              <a:off x="6607440" y="2018160"/>
              <a:ext cx="431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38"/>
            <p:cNvSpPr/>
            <p:nvPr/>
          </p:nvSpPr>
          <p:spPr>
            <a:xfrm>
              <a:off x="4768560" y="4119480"/>
              <a:ext cx="57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39"/>
            <p:cNvSpPr/>
            <p:nvPr/>
          </p:nvSpPr>
          <p:spPr>
            <a:xfrm>
              <a:off x="5176440" y="4119480"/>
              <a:ext cx="57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40"/>
            <p:cNvSpPr/>
            <p:nvPr/>
          </p:nvSpPr>
          <p:spPr>
            <a:xfrm>
              <a:off x="5509440" y="411948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41"/>
            <p:cNvSpPr/>
            <p:nvPr/>
          </p:nvSpPr>
          <p:spPr>
            <a:xfrm>
              <a:off x="5813640" y="411948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42"/>
            <p:cNvSpPr/>
            <p:nvPr/>
          </p:nvSpPr>
          <p:spPr>
            <a:xfrm>
              <a:off x="6108480" y="411948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43"/>
            <p:cNvSpPr/>
            <p:nvPr/>
          </p:nvSpPr>
          <p:spPr>
            <a:xfrm>
              <a:off x="6396120" y="411948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65"/>
            <p:cNvSpPr/>
            <p:nvPr/>
          </p:nvSpPr>
          <p:spPr>
            <a:xfrm>
              <a:off x="6720840" y="4119480"/>
              <a:ext cx="431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38"/>
            <p:cNvSpPr/>
            <p:nvPr/>
          </p:nvSpPr>
          <p:spPr>
            <a:xfrm>
              <a:off x="928440" y="4322520"/>
              <a:ext cx="57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Box 39"/>
            <p:cNvSpPr/>
            <p:nvPr/>
          </p:nvSpPr>
          <p:spPr>
            <a:xfrm>
              <a:off x="1336320" y="4322520"/>
              <a:ext cx="57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40"/>
            <p:cNvSpPr/>
            <p:nvPr/>
          </p:nvSpPr>
          <p:spPr>
            <a:xfrm>
              <a:off x="1669320" y="432252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41"/>
            <p:cNvSpPr/>
            <p:nvPr/>
          </p:nvSpPr>
          <p:spPr>
            <a:xfrm>
              <a:off x="1973520" y="432252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42"/>
            <p:cNvSpPr/>
            <p:nvPr/>
          </p:nvSpPr>
          <p:spPr>
            <a:xfrm>
              <a:off x="2268360" y="432252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Box 43"/>
            <p:cNvSpPr/>
            <p:nvPr/>
          </p:nvSpPr>
          <p:spPr>
            <a:xfrm>
              <a:off x="2556000" y="4322520"/>
              <a:ext cx="35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65"/>
            <p:cNvSpPr/>
            <p:nvPr/>
          </p:nvSpPr>
          <p:spPr>
            <a:xfrm>
              <a:off x="2880360" y="4322520"/>
              <a:ext cx="431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11:01:51Z</dcterms:created>
  <dc:creator>medear</dc:creator>
  <dc:description/>
  <dc:language>en-US</dc:language>
  <cp:lastModifiedBy>medear</cp:lastModifiedBy>
  <dcterms:modified xsi:type="dcterms:W3CDTF">2011-09-01T14:58:44Z</dcterms:modified>
  <cp:revision>49</cp:revision>
  <dc:subject/>
  <dc:title>Slide 1</dc:title>
</cp:coreProperties>
</file>